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1F1F1"/>
    <a:srgbClr val="00F8F8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52"/>
    <p:restoredTop sz="95794"/>
  </p:normalViewPr>
  <p:slideViewPr>
    <p:cSldViewPr snapToGrid="0" snapToObjects="1">
      <p:cViewPr varScale="1">
        <p:scale>
          <a:sx n="106" d="100"/>
          <a:sy n="106" d="100"/>
        </p:scale>
        <p:origin x="696" y="176"/>
      </p:cViewPr>
      <p:guideLst/>
    </p:cSldViewPr>
  </p:slideViewPr>
  <p:notesTextViewPr>
    <p:cViewPr>
      <p:scale>
        <a:sx n="105" d="100"/>
        <a:sy n="10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6043E6-5288-1C4A-AE46-87E99E423894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8160EB-670F-8345-B3A6-1794A808C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153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744AC4-F4EE-1D48-B741-38E5365DC9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048E4B-7419-0846-8CE8-89F36B1079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59" indent="0" algn="ctr">
              <a:buNone/>
              <a:defRPr sz="2000"/>
            </a:lvl2pPr>
            <a:lvl3pPr marL="914317" indent="0" algn="ctr">
              <a:buNone/>
              <a:defRPr sz="1800"/>
            </a:lvl3pPr>
            <a:lvl4pPr marL="1371475" indent="0" algn="ctr">
              <a:buNone/>
              <a:defRPr sz="1600"/>
            </a:lvl4pPr>
            <a:lvl5pPr marL="1828633" indent="0" algn="ctr">
              <a:buNone/>
              <a:defRPr sz="1600"/>
            </a:lvl5pPr>
            <a:lvl6pPr marL="2285792" indent="0" algn="ctr">
              <a:buNone/>
              <a:defRPr sz="1600"/>
            </a:lvl6pPr>
            <a:lvl7pPr marL="2742950" indent="0" algn="ctr">
              <a:buNone/>
              <a:defRPr sz="1600"/>
            </a:lvl7pPr>
            <a:lvl8pPr marL="3200109" indent="0" algn="ctr">
              <a:buNone/>
              <a:defRPr sz="1600"/>
            </a:lvl8pPr>
            <a:lvl9pPr marL="365726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3D4DF2-B1E2-1642-BB26-F58A61526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E6B35-4FD3-9546-8203-C9B4BCCC2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6647D0-8EE6-A04A-A04A-548385D9D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999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4E37BA-F3E2-B946-86B1-6D35A8DBD9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9CCFF5-9DCB-0E4D-9D8D-FD23D7DCCC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0A60D-9037-6347-AC84-13EE355B1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38C037-6238-9E46-B6F6-B6D11F751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285A0C-CEB4-B440-ADA4-360FD4A29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354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A0348A-D30F-9F4C-80DD-5FECEEF559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69ACAF-8EC7-DA46-B534-98B0A04AAD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46EC88-27D5-4E45-A8CC-B7E2E0AD3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66E07-85FD-1440-94EC-B529682EA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0558C4-CA96-DA4E-A967-14DF4CBE8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417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70DC9-E69E-5144-83CE-3A1023D9D8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5B62D8-AF3E-0C43-BAB7-ACC72FE29B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3FB05A-1E5E-9C41-9C9A-7D4E6DCEE5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7F709-90CF-5340-83B3-B426A9523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3E048-C1AB-4E4D-9345-304BF7D6C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864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0C2B3E-83AE-C846-A2E0-F5CC43C94B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ADB7CF-0EAD-2C4D-A503-24CEAE97A8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5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1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47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63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7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95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1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26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07AB38-0EE9-BC4A-B1B0-E320509C8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D697E7-F1BC-4B43-8649-B015D9933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7677E-5322-B446-92CD-FB9688366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505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B55CC-8881-3F46-991C-6D4772FD5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10FEE5-D3C1-B149-9CA2-B3CF048D7F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6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098F95-8E8F-394A-BBF0-A85AFA34B4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6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E87170-B37D-BC40-AF11-C389FAF45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F67C4A-7E1F-D14F-9A25-3CC053EF7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7E756B-FCCB-5B47-83F2-8E48EBFF5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2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19CCF7-600C-804A-84A2-CE71F7A36D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A99785-E40A-F94C-8819-F5D9A468E7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9" indent="0">
              <a:buNone/>
              <a:defRPr sz="2000" b="1"/>
            </a:lvl2pPr>
            <a:lvl3pPr marL="914317" indent="0">
              <a:buNone/>
              <a:defRPr sz="1800" b="1"/>
            </a:lvl3pPr>
            <a:lvl4pPr marL="1371475" indent="0">
              <a:buNone/>
              <a:defRPr sz="1600" b="1"/>
            </a:lvl4pPr>
            <a:lvl5pPr marL="1828633" indent="0">
              <a:buNone/>
              <a:defRPr sz="1600" b="1"/>
            </a:lvl5pPr>
            <a:lvl6pPr marL="2285792" indent="0">
              <a:buNone/>
              <a:defRPr sz="1600" b="1"/>
            </a:lvl6pPr>
            <a:lvl7pPr marL="2742950" indent="0">
              <a:buNone/>
              <a:defRPr sz="1600" b="1"/>
            </a:lvl7pPr>
            <a:lvl8pPr marL="3200109" indent="0">
              <a:buNone/>
              <a:defRPr sz="1600" b="1"/>
            </a:lvl8pPr>
            <a:lvl9pPr marL="365726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E320B0-2F9F-7F41-A913-E8A30E31EB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DF583F-6263-E949-A1ED-13A6409FC1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9" indent="0">
              <a:buNone/>
              <a:defRPr sz="2000" b="1"/>
            </a:lvl2pPr>
            <a:lvl3pPr marL="914317" indent="0">
              <a:buNone/>
              <a:defRPr sz="1800" b="1"/>
            </a:lvl3pPr>
            <a:lvl4pPr marL="1371475" indent="0">
              <a:buNone/>
              <a:defRPr sz="1600" b="1"/>
            </a:lvl4pPr>
            <a:lvl5pPr marL="1828633" indent="0">
              <a:buNone/>
              <a:defRPr sz="1600" b="1"/>
            </a:lvl5pPr>
            <a:lvl6pPr marL="2285792" indent="0">
              <a:buNone/>
              <a:defRPr sz="1600" b="1"/>
            </a:lvl6pPr>
            <a:lvl7pPr marL="2742950" indent="0">
              <a:buNone/>
              <a:defRPr sz="1600" b="1"/>
            </a:lvl7pPr>
            <a:lvl8pPr marL="3200109" indent="0">
              <a:buNone/>
              <a:defRPr sz="1600" b="1"/>
            </a:lvl8pPr>
            <a:lvl9pPr marL="365726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A11D22-8267-4347-93BA-EB444C5238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E2CD6F-8596-5E41-8C2A-5BB0129AF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734ADA-1212-944D-B678-BC7FBB4A1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E11094-D6CC-944E-9620-5F382BF28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111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272947-DC83-A845-9B52-2BBCCD4B4E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9217B5-5EB0-4042-9894-169DEB8B6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F03C26-0CFD-C74D-BBD3-CC05F890F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A37C49-8EA1-5149-A2A1-639858B05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370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60A0C3-5DD8-1440-94EC-FD58F656F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FED5B7-710D-3948-A136-463B3E73F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9A8AB0-4947-8D4D-B1D3-AD86B0A52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718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15AEBB-DB81-9F4F-8CE2-0E9FFA3230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6B17BE-9150-0B45-BEA2-435E64EA62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799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CA32BC-22A2-D34A-8C2B-998003E3A8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59" indent="0">
              <a:buNone/>
              <a:defRPr sz="1400"/>
            </a:lvl2pPr>
            <a:lvl3pPr marL="914317" indent="0">
              <a:buNone/>
              <a:defRPr sz="1200"/>
            </a:lvl3pPr>
            <a:lvl4pPr marL="1371475" indent="0">
              <a:buNone/>
              <a:defRPr sz="1000"/>
            </a:lvl4pPr>
            <a:lvl5pPr marL="1828633" indent="0">
              <a:buNone/>
              <a:defRPr sz="1000"/>
            </a:lvl5pPr>
            <a:lvl6pPr marL="2285792" indent="0">
              <a:buNone/>
              <a:defRPr sz="1000"/>
            </a:lvl6pPr>
            <a:lvl7pPr marL="2742950" indent="0">
              <a:buNone/>
              <a:defRPr sz="1000"/>
            </a:lvl7pPr>
            <a:lvl8pPr marL="3200109" indent="0">
              <a:buNone/>
              <a:defRPr sz="1000"/>
            </a:lvl8pPr>
            <a:lvl9pPr marL="3657267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4ED1B9-4D65-6E4F-9235-85EFE1235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CB5C12-E24A-7C4F-BB70-6C027A23E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FD416-D51C-444C-9181-DDF53856A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904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C336F4-2FC4-BF43-885C-70A5DDCCA3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B9E8A1-2767-C243-90FF-10BF90E495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59" indent="0">
              <a:buNone/>
              <a:defRPr sz="2799"/>
            </a:lvl2pPr>
            <a:lvl3pPr marL="914317" indent="0">
              <a:buNone/>
              <a:defRPr sz="2400"/>
            </a:lvl3pPr>
            <a:lvl4pPr marL="1371475" indent="0">
              <a:buNone/>
              <a:defRPr sz="2000"/>
            </a:lvl4pPr>
            <a:lvl5pPr marL="1828633" indent="0">
              <a:buNone/>
              <a:defRPr sz="2000"/>
            </a:lvl5pPr>
            <a:lvl6pPr marL="2285792" indent="0">
              <a:buNone/>
              <a:defRPr sz="2000"/>
            </a:lvl6pPr>
            <a:lvl7pPr marL="2742950" indent="0">
              <a:buNone/>
              <a:defRPr sz="2000"/>
            </a:lvl7pPr>
            <a:lvl8pPr marL="3200109" indent="0">
              <a:buNone/>
              <a:defRPr sz="2000"/>
            </a:lvl8pPr>
            <a:lvl9pPr marL="3657267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49ABC7-A3F0-B744-9EB6-FD5E933E93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59" indent="0">
              <a:buNone/>
              <a:defRPr sz="1400"/>
            </a:lvl2pPr>
            <a:lvl3pPr marL="914317" indent="0">
              <a:buNone/>
              <a:defRPr sz="1200"/>
            </a:lvl3pPr>
            <a:lvl4pPr marL="1371475" indent="0">
              <a:buNone/>
              <a:defRPr sz="1000"/>
            </a:lvl4pPr>
            <a:lvl5pPr marL="1828633" indent="0">
              <a:buNone/>
              <a:defRPr sz="1000"/>
            </a:lvl5pPr>
            <a:lvl6pPr marL="2285792" indent="0">
              <a:buNone/>
              <a:defRPr sz="1000"/>
            </a:lvl6pPr>
            <a:lvl7pPr marL="2742950" indent="0">
              <a:buNone/>
              <a:defRPr sz="1000"/>
            </a:lvl7pPr>
            <a:lvl8pPr marL="3200109" indent="0">
              <a:buNone/>
              <a:defRPr sz="1000"/>
            </a:lvl8pPr>
            <a:lvl9pPr marL="3657267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24A8E1-5735-8F40-93D3-DCD3F6779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2EF681-6118-5D4E-B6C5-6F80B03F6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DE7514-D013-2544-B42C-154550847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858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DAF07A-5396-E142-9680-69B49FA8A4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A3D35D-179B-8943-A746-CD9C4A1D47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6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E7DD8D-41DC-7448-B6B6-A2F9CC7830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1B3B90-C74D-A744-B6C6-FBB917305C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771DAA-C07E-534B-9752-B62B0D3346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60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1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79" indent="-228579" algn="l" defTabSz="91431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37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96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54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13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71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29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88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846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59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17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75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33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92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950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109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267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A210E68A-10BF-1E41-903A-AA1B8E0EF198}"/>
              </a:ext>
            </a:extLst>
          </p:cNvPr>
          <p:cNvSpPr txBox="1"/>
          <p:nvPr/>
        </p:nvSpPr>
        <p:spPr>
          <a:xfrm>
            <a:off x="6145289" y="1376830"/>
            <a:ext cx="877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94FC193-3B39-364A-A694-B3AC5DC92616}"/>
              </a:ext>
            </a:extLst>
          </p:cNvPr>
          <p:cNvSpPr txBox="1"/>
          <p:nvPr/>
        </p:nvSpPr>
        <p:spPr>
          <a:xfrm>
            <a:off x="8561981" y="1356088"/>
            <a:ext cx="1040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MD CM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559E7F13-528D-5C48-AE68-94C0274BDF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32119" y="1628206"/>
            <a:ext cx="2908192" cy="218114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9FE9E65C-6311-E240-8446-D25549D0FBD5}"/>
              </a:ext>
            </a:extLst>
          </p:cNvPr>
          <p:cNvSpPr txBox="1"/>
          <p:nvPr/>
        </p:nvSpPr>
        <p:spPr>
          <a:xfrm>
            <a:off x="7082385" y="968173"/>
            <a:ext cx="171585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MDE Presenc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6C89A5-0DE2-1B48-AAD5-4A670ADCB337}"/>
              </a:ext>
            </a:extLst>
          </p:cNvPr>
          <p:cNvSpPr txBox="1"/>
          <p:nvPr/>
        </p:nvSpPr>
        <p:spPr>
          <a:xfrm>
            <a:off x="304800" y="371061"/>
            <a:ext cx="17011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dditional File 7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7672F13B-037B-4248-B227-5CBE65CEE4DD}"/>
              </a:ext>
            </a:extLst>
          </p:cNvPr>
          <p:cNvGrpSpPr/>
          <p:nvPr/>
        </p:nvGrpSpPr>
        <p:grpSpPr>
          <a:xfrm>
            <a:off x="1941745" y="1357006"/>
            <a:ext cx="2904249" cy="2778518"/>
            <a:chOff x="592326" y="1766084"/>
            <a:chExt cx="2694480" cy="2669879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74BDB8FD-6F7F-E64F-B406-F71A1B20914E}"/>
                </a:ext>
              </a:extLst>
            </p:cNvPr>
            <p:cNvGrpSpPr/>
            <p:nvPr/>
          </p:nvGrpSpPr>
          <p:grpSpPr>
            <a:xfrm>
              <a:off x="875690" y="2035293"/>
              <a:ext cx="2174532" cy="2161744"/>
              <a:chOff x="350230" y="984010"/>
              <a:chExt cx="2174532" cy="2161744"/>
            </a:xfrm>
          </p:grpSpPr>
          <p:pic>
            <p:nvPicPr>
              <p:cNvPr id="17" name="Picture 16">
                <a:extLst>
                  <a:ext uri="{FF2B5EF4-FFF2-40B4-BE49-F238E27FC236}">
                    <a16:creationId xmlns:a16="http://schemas.microsoft.com/office/drawing/2014/main" id="{0D995141-76C4-C94E-BC75-865D3AEAB35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23070" t="4982" r="18957" b="18899"/>
              <a:stretch/>
            </p:blipFill>
            <p:spPr>
              <a:xfrm>
                <a:off x="350230" y="1004332"/>
                <a:ext cx="2174532" cy="2141422"/>
              </a:xfrm>
              <a:prstGeom prst="rect">
                <a:avLst/>
              </a:prstGeom>
            </p:spPr>
          </p:pic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4381A075-89C7-DF49-8586-6A8DBB8AB9FA}"/>
                  </a:ext>
                </a:extLst>
              </p:cNvPr>
              <p:cNvSpPr txBox="1"/>
              <p:nvPr/>
            </p:nvSpPr>
            <p:spPr>
              <a:xfrm>
                <a:off x="1290526" y="984010"/>
                <a:ext cx="252047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1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7EC3397A-5219-164B-B988-786A7ED42294}"/>
                  </a:ext>
                </a:extLst>
              </p:cNvPr>
              <p:cNvSpPr txBox="1"/>
              <p:nvPr/>
            </p:nvSpPr>
            <p:spPr>
              <a:xfrm>
                <a:off x="510366" y="1430684"/>
                <a:ext cx="252047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2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99DCA01-E530-1643-90BE-FA49303B0E02}"/>
                  </a:ext>
                </a:extLst>
              </p:cNvPr>
              <p:cNvSpPr txBox="1"/>
              <p:nvPr/>
            </p:nvSpPr>
            <p:spPr>
              <a:xfrm>
                <a:off x="488934" y="2309600"/>
                <a:ext cx="252047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3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B5D1F85F-3C58-264D-A2D8-5850B284DACF}"/>
                  </a:ext>
                </a:extLst>
              </p:cNvPr>
              <p:cNvSpPr txBox="1"/>
              <p:nvPr/>
            </p:nvSpPr>
            <p:spPr>
              <a:xfrm>
                <a:off x="1290526" y="2791409"/>
                <a:ext cx="252047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4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4FC4F535-389F-9B46-A345-1D39C3B63758}"/>
                  </a:ext>
                </a:extLst>
              </p:cNvPr>
              <p:cNvSpPr txBox="1"/>
              <p:nvPr/>
            </p:nvSpPr>
            <p:spPr>
              <a:xfrm>
                <a:off x="2089020" y="2309600"/>
                <a:ext cx="252047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5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6863F95-7883-4F43-BAC9-45D8F4C0F0CE}"/>
                  </a:ext>
                </a:extLst>
              </p:cNvPr>
              <p:cNvSpPr txBox="1"/>
              <p:nvPr/>
            </p:nvSpPr>
            <p:spPr>
              <a:xfrm>
                <a:off x="2037031" y="1430684"/>
                <a:ext cx="252047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6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FDA50C0D-2301-E642-80E2-72734B29131F}"/>
                  </a:ext>
                </a:extLst>
              </p:cNvPr>
              <p:cNvSpPr txBox="1"/>
              <p:nvPr/>
            </p:nvSpPr>
            <p:spPr>
              <a:xfrm>
                <a:off x="1290526" y="1261310"/>
                <a:ext cx="252047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7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71ACED4B-93BA-A44E-AAC3-BACCE4B37965}"/>
                  </a:ext>
                </a:extLst>
              </p:cNvPr>
              <p:cNvSpPr txBox="1"/>
              <p:nvPr/>
            </p:nvSpPr>
            <p:spPr>
              <a:xfrm>
                <a:off x="1238429" y="1506405"/>
                <a:ext cx="342962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13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70F8B291-3E40-1F4B-A77B-9D178C2A48C6}"/>
                  </a:ext>
                </a:extLst>
              </p:cNvPr>
              <p:cNvSpPr txBox="1"/>
              <p:nvPr/>
            </p:nvSpPr>
            <p:spPr>
              <a:xfrm>
                <a:off x="1238429" y="1875002"/>
                <a:ext cx="342962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17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FAFE63FF-994A-1043-AF26-C6D2442C94DB}"/>
                  </a:ext>
                </a:extLst>
              </p:cNvPr>
              <p:cNvSpPr txBox="1"/>
              <p:nvPr/>
            </p:nvSpPr>
            <p:spPr>
              <a:xfrm>
                <a:off x="844213" y="1875002"/>
                <a:ext cx="342962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14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89F0CCD4-97F1-8346-BB81-6DCBCC5A9C9F}"/>
                  </a:ext>
                </a:extLst>
              </p:cNvPr>
              <p:cNvSpPr txBox="1"/>
              <p:nvPr/>
            </p:nvSpPr>
            <p:spPr>
              <a:xfrm>
                <a:off x="1610582" y="1875002"/>
                <a:ext cx="342962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16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DE2DE9EE-CEA1-0645-914F-2423A5D436C9}"/>
                  </a:ext>
                </a:extLst>
              </p:cNvPr>
              <p:cNvSpPr txBox="1"/>
              <p:nvPr/>
            </p:nvSpPr>
            <p:spPr>
              <a:xfrm>
                <a:off x="1238429" y="2266489"/>
                <a:ext cx="342962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15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75D4E16C-C4CA-084A-8D55-B49BA2A99128}"/>
                  </a:ext>
                </a:extLst>
              </p:cNvPr>
              <p:cNvSpPr txBox="1"/>
              <p:nvPr/>
            </p:nvSpPr>
            <p:spPr>
              <a:xfrm>
                <a:off x="1238429" y="2533126"/>
                <a:ext cx="342962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10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93D9FE8D-8ED8-8342-AC6B-E06EDC270F3E}"/>
                  </a:ext>
                </a:extLst>
              </p:cNvPr>
              <p:cNvSpPr txBox="1"/>
              <p:nvPr/>
            </p:nvSpPr>
            <p:spPr>
              <a:xfrm>
                <a:off x="709954" y="2189024"/>
                <a:ext cx="252047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9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E059DEF7-0EF9-F941-9EF5-88C08A5E2645}"/>
                  </a:ext>
                </a:extLst>
              </p:cNvPr>
              <p:cNvSpPr txBox="1"/>
              <p:nvPr/>
            </p:nvSpPr>
            <p:spPr>
              <a:xfrm>
                <a:off x="733718" y="1568627"/>
                <a:ext cx="252047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8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540BEAFF-2923-744B-85C2-4A814484FC2C}"/>
                  </a:ext>
                </a:extLst>
              </p:cNvPr>
              <p:cNvSpPr txBox="1"/>
              <p:nvPr/>
            </p:nvSpPr>
            <p:spPr>
              <a:xfrm>
                <a:off x="1787575" y="1566541"/>
                <a:ext cx="342962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12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F52D9160-517E-AE4C-A7FC-E7D3EFBDEFAC}"/>
                  </a:ext>
                </a:extLst>
              </p:cNvPr>
              <p:cNvSpPr txBox="1"/>
              <p:nvPr/>
            </p:nvSpPr>
            <p:spPr>
              <a:xfrm>
                <a:off x="1811412" y="2189024"/>
                <a:ext cx="342962" cy="2950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600" dirty="0"/>
                  <a:t>11</a:t>
                </a:r>
              </a:p>
            </p:txBody>
          </p:sp>
        </p:grp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230BEBD0-EBC4-1C4B-B3FB-A62B1B998BC4}"/>
                </a:ext>
              </a:extLst>
            </p:cNvPr>
            <p:cNvSpPr txBox="1"/>
            <p:nvPr/>
          </p:nvSpPr>
          <p:spPr>
            <a:xfrm>
              <a:off x="1451745" y="1766084"/>
              <a:ext cx="1004550" cy="321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ANTERIOR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5AA23D4-9DA0-6D46-B80C-0C6133BC5D32}"/>
                </a:ext>
              </a:extLst>
            </p:cNvPr>
            <p:cNvSpPr txBox="1"/>
            <p:nvPr/>
          </p:nvSpPr>
          <p:spPr>
            <a:xfrm rot="5400000">
              <a:off x="2699612" y="2864647"/>
              <a:ext cx="852125" cy="3222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LATERAL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F3D1E35-62D2-9B49-ABF6-42D9CF6179B9}"/>
                </a:ext>
              </a:extLst>
            </p:cNvPr>
            <p:cNvSpPr txBox="1"/>
            <p:nvPr/>
          </p:nvSpPr>
          <p:spPr>
            <a:xfrm rot="5400000">
              <a:off x="385119" y="2945060"/>
              <a:ext cx="736676" cy="32226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SEPTAL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0387210-1B9D-0444-A82D-D62C6390C131}"/>
                </a:ext>
              </a:extLst>
            </p:cNvPr>
            <p:cNvSpPr txBox="1"/>
            <p:nvPr/>
          </p:nvSpPr>
          <p:spPr>
            <a:xfrm>
              <a:off x="1363715" y="4114090"/>
              <a:ext cx="933217" cy="3218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INFERIOR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44EA6361-DDFC-5047-A338-5BC283CBF92C}"/>
              </a:ext>
            </a:extLst>
          </p:cNvPr>
          <p:cNvSpPr txBox="1"/>
          <p:nvPr/>
        </p:nvSpPr>
        <p:spPr>
          <a:xfrm>
            <a:off x="2543798" y="968173"/>
            <a:ext cx="21876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/>
              <a:t>17 Segment Mode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00E36AF-7B6B-B947-BC94-E65ECC1A4E4D}"/>
              </a:ext>
            </a:extLst>
          </p:cNvPr>
          <p:cNvSpPr txBox="1"/>
          <p:nvPr/>
        </p:nvSpPr>
        <p:spPr>
          <a:xfrm>
            <a:off x="1525830" y="4341387"/>
            <a:ext cx="3858704" cy="1615827"/>
          </a:xfrm>
          <a:prstGeom prst="rect">
            <a:avLst/>
          </a:prstGeom>
          <a:noFill/>
          <a:ln w="38100">
            <a:solidFill>
              <a:schemeClr val="tx1"/>
            </a:solidFill>
          </a:ln>
        </p:spPr>
        <p:txBody>
          <a:bodyPr wrap="square" numCol="2" rtlCol="0">
            <a:spAutoFit/>
          </a:bodyPr>
          <a:lstStyle/>
          <a:p>
            <a:pPr marL="342869" indent="-342869">
              <a:buAutoNum type="arabicPeriod"/>
            </a:pPr>
            <a:r>
              <a:rPr lang="en-US" sz="1100" dirty="0"/>
              <a:t>Basal anterior</a:t>
            </a:r>
          </a:p>
          <a:p>
            <a:pPr marL="342869" indent="-342869">
              <a:buAutoNum type="arabicPeriod"/>
            </a:pPr>
            <a:r>
              <a:rPr lang="en-US" sz="1100" dirty="0"/>
              <a:t>Basal anteroseptal</a:t>
            </a:r>
          </a:p>
          <a:p>
            <a:pPr marL="342869" indent="-342869">
              <a:buAutoNum type="arabicPeriod"/>
            </a:pPr>
            <a:r>
              <a:rPr lang="en-US" sz="1100" dirty="0"/>
              <a:t>Basal inferoseptal</a:t>
            </a:r>
          </a:p>
          <a:p>
            <a:pPr marL="342869" indent="-342869">
              <a:buAutoNum type="arabicPeriod"/>
            </a:pPr>
            <a:r>
              <a:rPr lang="en-US" sz="1100" dirty="0"/>
              <a:t>Basal inferior</a:t>
            </a:r>
          </a:p>
          <a:p>
            <a:pPr marL="342869" indent="-342869">
              <a:buAutoNum type="arabicPeriod"/>
            </a:pPr>
            <a:r>
              <a:rPr lang="en-US" sz="1100" dirty="0"/>
              <a:t>Basal inferolateral</a:t>
            </a:r>
          </a:p>
          <a:p>
            <a:pPr marL="342869" indent="-342869">
              <a:buAutoNum type="arabicPeriod"/>
            </a:pPr>
            <a:r>
              <a:rPr lang="en-US" sz="1100" dirty="0"/>
              <a:t>Basal anterolateral</a:t>
            </a:r>
          </a:p>
          <a:p>
            <a:pPr marL="342869" indent="-342869">
              <a:buAutoNum type="arabicPeriod"/>
            </a:pPr>
            <a:r>
              <a:rPr lang="en-US" sz="1100" dirty="0"/>
              <a:t>Mid-LV anterior</a:t>
            </a:r>
          </a:p>
          <a:p>
            <a:pPr marL="342869" indent="-342869">
              <a:buAutoNum type="arabicPeriod"/>
            </a:pPr>
            <a:r>
              <a:rPr lang="en-US" sz="1100" dirty="0"/>
              <a:t>Mid-LV anteroseptal</a:t>
            </a:r>
          </a:p>
          <a:p>
            <a:pPr marL="342869" indent="-342869">
              <a:buAutoNum type="arabicPeriod"/>
            </a:pPr>
            <a:r>
              <a:rPr lang="en-US" sz="1100" dirty="0"/>
              <a:t>Mid-LV inferoseptal</a:t>
            </a:r>
          </a:p>
          <a:p>
            <a:pPr marL="342869" indent="-342869">
              <a:buAutoNum type="arabicPeriod"/>
            </a:pPr>
            <a:r>
              <a:rPr lang="en-US" sz="1100" dirty="0"/>
              <a:t>Mid-LV inferior</a:t>
            </a:r>
          </a:p>
          <a:p>
            <a:pPr marL="342869" indent="-342869">
              <a:buAutoNum type="arabicPeriod"/>
            </a:pPr>
            <a:r>
              <a:rPr lang="en-US" sz="1100" dirty="0"/>
              <a:t>Mid-LV inferolateral</a:t>
            </a:r>
          </a:p>
          <a:p>
            <a:pPr marL="342869" indent="-342869">
              <a:buAutoNum type="arabicPeriod"/>
            </a:pPr>
            <a:r>
              <a:rPr lang="en-US" sz="1100" dirty="0"/>
              <a:t>Mid-LV anterolateral</a:t>
            </a:r>
          </a:p>
          <a:p>
            <a:pPr marL="342869" indent="-342869">
              <a:buAutoNum type="arabicPeriod"/>
            </a:pPr>
            <a:r>
              <a:rPr lang="en-US" sz="1100" dirty="0"/>
              <a:t>Apical anterior</a:t>
            </a:r>
          </a:p>
          <a:p>
            <a:pPr marL="342869" indent="-342869">
              <a:buAutoNum type="arabicPeriod"/>
            </a:pPr>
            <a:r>
              <a:rPr lang="en-US" sz="1100" dirty="0"/>
              <a:t>Apical septal</a:t>
            </a:r>
          </a:p>
          <a:p>
            <a:pPr marL="342869" indent="-342869">
              <a:buAutoNum type="arabicPeriod"/>
            </a:pPr>
            <a:r>
              <a:rPr lang="en-US" sz="1100" dirty="0"/>
              <a:t>Apical inferior</a:t>
            </a:r>
          </a:p>
          <a:p>
            <a:pPr marL="342869" indent="-342869">
              <a:buAutoNum type="arabicPeriod"/>
            </a:pPr>
            <a:r>
              <a:rPr lang="en-US" sz="1100" dirty="0"/>
              <a:t>Apical lateral</a:t>
            </a:r>
          </a:p>
          <a:p>
            <a:pPr marL="342869" indent="-342869">
              <a:buAutoNum type="arabicPeriod"/>
            </a:pPr>
            <a:r>
              <a:rPr lang="en-US" sz="1100" dirty="0"/>
              <a:t>Apex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5A6A022-8F2D-C942-B529-180D3A2369AA}"/>
              </a:ext>
            </a:extLst>
          </p:cNvPr>
          <p:cNvSpPr txBox="1"/>
          <p:nvPr/>
        </p:nvSpPr>
        <p:spPr>
          <a:xfrm>
            <a:off x="1753477" y="1455846"/>
            <a:ext cx="249420" cy="30777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3798DE7-25B1-8D4F-8624-566040BBD923}"/>
              </a:ext>
            </a:extLst>
          </p:cNvPr>
          <p:cNvSpPr txBox="1"/>
          <p:nvPr/>
        </p:nvSpPr>
        <p:spPr>
          <a:xfrm>
            <a:off x="5550182" y="1455847"/>
            <a:ext cx="249420" cy="30777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C68EC94-957D-7948-99A9-6921E1059C92}"/>
              </a:ext>
            </a:extLst>
          </p:cNvPr>
          <p:cNvSpPr txBox="1"/>
          <p:nvPr/>
        </p:nvSpPr>
        <p:spPr>
          <a:xfrm>
            <a:off x="8126436" y="1452007"/>
            <a:ext cx="249420" cy="30777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BA6831CF-772A-6E45-ABEF-A9696EA0BC28}"/>
              </a:ext>
            </a:extLst>
          </p:cNvPr>
          <p:cNvSpPr txBox="1"/>
          <p:nvPr/>
        </p:nvSpPr>
        <p:spPr>
          <a:xfrm>
            <a:off x="5550182" y="3850273"/>
            <a:ext cx="249420" cy="307777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F430E90E-5398-8A42-9F53-C790FA259E2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09620" y="1629501"/>
            <a:ext cx="2908192" cy="2181144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ED6CE41A-DD7F-B541-8841-8B47DCD17CC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736949" y="3740300"/>
            <a:ext cx="4363827" cy="2527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1323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401</TotalTime>
  <Words>69</Words>
  <Application>Microsoft Macintosh PowerPoint</Application>
  <PresentationFormat>Widescreen</PresentationFormat>
  <Paragraphs>4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er Earl</dc:creator>
  <cp:lastModifiedBy>Conner Earl</cp:lastModifiedBy>
  <cp:revision>63</cp:revision>
  <cp:lastPrinted>2022-02-06T03:55:09Z</cp:lastPrinted>
  <dcterms:created xsi:type="dcterms:W3CDTF">2022-01-21T23:01:07Z</dcterms:created>
  <dcterms:modified xsi:type="dcterms:W3CDTF">2022-10-27T13:59:12Z</dcterms:modified>
</cp:coreProperties>
</file>